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C2AB2D-CE7A-424E-8641-DDAB7D4E738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5A8EB7-8397-4E7F-BEF4-1064ACB354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B67627-D153-4625-B0F0-D6FF5E68394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40CE85-D782-4AF5-B1C8-86A8D72BCC2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7069C2-22BF-49DD-A4C6-211582AFA3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D67522-4F33-457D-B484-03862B86D5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E858BE-0856-49A4-867F-9FB6E7B7185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15BECE-CC20-4711-ACC2-5E3E20B193F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81097B-BA6B-48AE-A384-1442AB64832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917810-E265-449C-8763-40A8CAB7CB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201B7A-B2F3-4751-8928-08C8D00D1F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40CA71-1E42-4125-A53B-BCD0E6079B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B58085E-82F1-4115-AF67-6DC2A739403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704880" y="3595680"/>
            <a:ext cx="3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713880" y="1397160"/>
            <a:ext cx="784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571320" y="1114560"/>
            <a:ext cx="234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571320" y="833400"/>
            <a:ext cx="234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3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571320" y="480960"/>
            <a:ext cx="234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5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rot="16200000">
            <a:off x="927720" y="1799640"/>
            <a:ext cx="107820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CMVcoreIR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ALB/c (n=6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 rot="16200000">
            <a:off x="1297440" y="1854720"/>
            <a:ext cx="118944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CMVcore Koza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ALB/c (n=7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 rot="16200000">
            <a:off x="584640" y="1727640"/>
            <a:ext cx="91368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CMVcor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ALB/c (n=6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58920" y="128520"/>
            <a:ext cx="3052440" cy="2957760"/>
          </a:xfrm>
          <a:prstGeom prst="rect">
            <a:avLst/>
          </a:pr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824040" y="1231920"/>
            <a:ext cx="2517480" cy="144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824040" y="1077840"/>
            <a:ext cx="2517480" cy="180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824040" y="911160"/>
            <a:ext cx="2517480" cy="180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824040" y="744480"/>
            <a:ext cx="2517480" cy="180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824040" y="590400"/>
            <a:ext cx="2517480" cy="180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806400" y="411120"/>
            <a:ext cx="2532240" cy="180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950760" y="600120"/>
            <a:ext cx="169920" cy="792000"/>
          </a:xfrm>
          <a:prstGeom prst="rect">
            <a:avLst/>
          </a:prstGeom>
          <a:solidFill>
            <a:srgbClr val="333399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1373040" y="793800"/>
            <a:ext cx="168480" cy="596880"/>
          </a:xfrm>
          <a:prstGeom prst="rect">
            <a:avLst/>
          </a:prstGeom>
          <a:solidFill>
            <a:srgbClr val="333399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212920" y="1133640"/>
            <a:ext cx="168480" cy="263520"/>
          </a:xfrm>
          <a:prstGeom prst="rect">
            <a:avLst/>
          </a:prstGeom>
          <a:solidFill>
            <a:srgbClr val="333399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9" name=""/>
          <p:cNvGrpSpPr/>
          <p:nvPr/>
        </p:nvGrpSpPr>
        <p:grpSpPr>
          <a:xfrm>
            <a:off x="2284560" y="1044360"/>
            <a:ext cx="23760" cy="176400"/>
            <a:chOff x="2284560" y="1044360"/>
            <a:chExt cx="23760" cy="176400"/>
          </a:xfrm>
        </p:grpSpPr>
        <p:sp>
          <p:nvSpPr>
            <p:cNvPr id="60" name=""/>
            <p:cNvSpPr/>
            <p:nvPr/>
          </p:nvSpPr>
          <p:spPr>
            <a:xfrm flipV="1">
              <a:off x="2295000" y="1044360"/>
              <a:ext cx="0" cy="874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284560" y="1044720"/>
              <a:ext cx="23760" cy="3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295000" y="1132200"/>
              <a:ext cx="0" cy="878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040" bIns="41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2284560" y="1220400"/>
              <a:ext cx="23760" cy="3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4" name=""/>
          <p:cNvGrpSpPr/>
          <p:nvPr/>
        </p:nvGrpSpPr>
        <p:grpSpPr>
          <a:xfrm>
            <a:off x="1025640" y="411120"/>
            <a:ext cx="23760" cy="410760"/>
            <a:chOff x="1025640" y="411120"/>
            <a:chExt cx="23760" cy="410760"/>
          </a:xfrm>
        </p:grpSpPr>
        <p:sp>
          <p:nvSpPr>
            <p:cNvPr id="65" name=""/>
            <p:cNvSpPr/>
            <p:nvPr/>
          </p:nvSpPr>
          <p:spPr>
            <a:xfrm flipV="1">
              <a:off x="1035360" y="411120"/>
              <a:ext cx="1080" cy="2109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1025640" y="411120"/>
              <a:ext cx="2376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1035360" y="622080"/>
              <a:ext cx="1080" cy="1983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1025640" y="820800"/>
              <a:ext cx="23760" cy="10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9" name=""/>
          <p:cNvGrpSpPr/>
          <p:nvPr/>
        </p:nvGrpSpPr>
        <p:grpSpPr>
          <a:xfrm>
            <a:off x="1440000" y="622440"/>
            <a:ext cx="21960" cy="320040"/>
            <a:chOff x="1440000" y="622440"/>
            <a:chExt cx="21960" cy="320040"/>
          </a:xfrm>
        </p:grpSpPr>
        <p:sp>
          <p:nvSpPr>
            <p:cNvPr id="70" name=""/>
            <p:cNvSpPr/>
            <p:nvPr/>
          </p:nvSpPr>
          <p:spPr>
            <a:xfrm flipV="1">
              <a:off x="1449000" y="622440"/>
              <a:ext cx="1080" cy="1656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1440000" y="622440"/>
              <a:ext cx="2196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1449000" y="788040"/>
              <a:ext cx="1080" cy="1533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1440000" y="941400"/>
              <a:ext cx="21960" cy="10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4" name=""/>
          <p:cNvSpPr/>
          <p:nvPr/>
        </p:nvSpPr>
        <p:spPr>
          <a:xfrm>
            <a:off x="811080" y="1397160"/>
            <a:ext cx="129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811080" y="1231920"/>
            <a:ext cx="129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811080" y="1077840"/>
            <a:ext cx="129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811080" y="911160"/>
            <a:ext cx="129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811080" y="744480"/>
            <a:ext cx="129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811080" y="590400"/>
            <a:ext cx="129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824040" y="1397160"/>
            <a:ext cx="1265040" cy="144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 flipV="1">
            <a:off x="1246320" y="1396800"/>
            <a:ext cx="1440" cy="442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 flipV="1">
            <a:off x="1666800" y="1396800"/>
            <a:ext cx="0" cy="442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 flipV="1">
            <a:off x="2089080" y="1396800"/>
            <a:ext cx="1800" cy="442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1792440" y="857160"/>
            <a:ext cx="171360" cy="541440"/>
          </a:xfrm>
          <a:prstGeom prst="rect">
            <a:avLst/>
          </a:prstGeom>
          <a:solidFill>
            <a:srgbClr val="333399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3063960" y="1198440"/>
            <a:ext cx="168120" cy="193680"/>
          </a:xfrm>
          <a:prstGeom prst="rect">
            <a:avLst/>
          </a:prstGeom>
          <a:solidFill>
            <a:srgbClr val="333399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2630520" y="1222200"/>
            <a:ext cx="171360" cy="169920"/>
          </a:xfrm>
          <a:prstGeom prst="rect">
            <a:avLst/>
          </a:prstGeom>
          <a:solidFill>
            <a:srgbClr val="333399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7" name=""/>
          <p:cNvGrpSpPr/>
          <p:nvPr/>
        </p:nvGrpSpPr>
        <p:grpSpPr>
          <a:xfrm>
            <a:off x="1873080" y="763200"/>
            <a:ext cx="20880" cy="411120"/>
            <a:chOff x="1873080" y="763200"/>
            <a:chExt cx="20880" cy="411120"/>
          </a:xfrm>
        </p:grpSpPr>
        <p:sp>
          <p:nvSpPr>
            <p:cNvPr id="88" name=""/>
            <p:cNvSpPr/>
            <p:nvPr/>
          </p:nvSpPr>
          <p:spPr>
            <a:xfrm flipV="1">
              <a:off x="1881720" y="763200"/>
              <a:ext cx="720" cy="210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1873080" y="763560"/>
              <a:ext cx="2088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1881720" y="974160"/>
              <a:ext cx="720" cy="198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1873080" y="1173240"/>
              <a:ext cx="2088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2" name=""/>
          <p:cNvSpPr/>
          <p:nvPr/>
        </p:nvSpPr>
        <p:spPr>
          <a:xfrm>
            <a:off x="2090880" y="1397160"/>
            <a:ext cx="1244520" cy="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 flipV="1">
            <a:off x="2513160" y="1382760"/>
            <a:ext cx="1440" cy="46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 flipV="1">
            <a:off x="2932200" y="1382760"/>
            <a:ext cx="0" cy="46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817560" y="411120"/>
            <a:ext cx="0" cy="98604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3335400" y="411120"/>
            <a:ext cx="0" cy="98604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7" name=""/>
          <p:cNvGrpSpPr/>
          <p:nvPr/>
        </p:nvGrpSpPr>
        <p:grpSpPr>
          <a:xfrm>
            <a:off x="2705040" y="1185480"/>
            <a:ext cx="23760" cy="105120"/>
            <a:chOff x="2705040" y="1185480"/>
            <a:chExt cx="23760" cy="105120"/>
          </a:xfrm>
        </p:grpSpPr>
        <p:sp>
          <p:nvSpPr>
            <p:cNvPr id="98" name=""/>
            <p:cNvSpPr/>
            <p:nvPr/>
          </p:nvSpPr>
          <p:spPr>
            <a:xfrm flipV="1">
              <a:off x="2715480" y="1185480"/>
              <a:ext cx="0" cy="522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2705040" y="1185840"/>
              <a:ext cx="237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2715480" y="1238040"/>
              <a:ext cx="0" cy="522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2705040" y="1290600"/>
              <a:ext cx="237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2" name=""/>
          <p:cNvGrpSpPr/>
          <p:nvPr/>
        </p:nvGrpSpPr>
        <p:grpSpPr>
          <a:xfrm>
            <a:off x="3138480" y="1128240"/>
            <a:ext cx="22320" cy="141840"/>
            <a:chOff x="3138480" y="1128240"/>
            <a:chExt cx="22320" cy="141840"/>
          </a:xfrm>
        </p:grpSpPr>
        <p:sp>
          <p:nvSpPr>
            <p:cNvPr id="103" name=""/>
            <p:cNvSpPr/>
            <p:nvPr/>
          </p:nvSpPr>
          <p:spPr>
            <a:xfrm flipV="1">
              <a:off x="3148200" y="1128240"/>
              <a:ext cx="0" cy="702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400" bIns="23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3138480" y="1128600"/>
              <a:ext cx="2232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3148200" y="1198800"/>
              <a:ext cx="0" cy="705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760" bIns="23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3138480" y="1269720"/>
              <a:ext cx="22320" cy="3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7" name=""/>
          <p:cNvSpPr/>
          <p:nvPr/>
        </p:nvSpPr>
        <p:spPr>
          <a:xfrm>
            <a:off x="362160" y="12852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 rot="16200000">
            <a:off x="1681200" y="1826280"/>
            <a:ext cx="13694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CMVcore Koza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57BL6 (n=10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 rot="16200000">
            <a:off x="1969920" y="1909440"/>
            <a:ext cx="16401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lv-LV" sz="1200" spc="-1" strike="noStrike">
                <a:solidFill>
                  <a:srgbClr val="000000"/>
                </a:solidFill>
                <a:latin typeface="Arial"/>
              </a:rPr>
              <a:t>Empty vector BALB/c (n=7) C57BL6 (n=12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 rot="16200000">
            <a:off x="2392200" y="1943640"/>
            <a:ext cx="16466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lacebo BALB/c(n=7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57BL6 (n=12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1211400" y="2805120"/>
            <a:ext cx="122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ouse group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 rot="16200000">
            <a:off x="114480" y="826920"/>
            <a:ext cx="71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lv-LV" sz="1200" spc="-1" strike="noStrike">
                <a:solidFill>
                  <a:srgbClr val="000000"/>
                </a:solidFill>
                <a:latin typeface="Arial"/>
              </a:rPr>
              <a:t>Ab tit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3712320" y="16686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3687120" y="13255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3687120" y="10429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3687120" y="7621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 rot="16200000">
            <a:off x="3560040" y="2092680"/>
            <a:ext cx="105588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CMVcor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ALB/c (n=4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 rot="16200000">
            <a:off x="3983760" y="2155320"/>
            <a:ext cx="107820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CMVcoreIR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ALB/c (n=4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 rot="16200000">
            <a:off x="4165200" y="2331720"/>
            <a:ext cx="144540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CMVcore191 Koza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ALB/c (n=4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3543480" y="550800"/>
            <a:ext cx="291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3832200" y="198360"/>
            <a:ext cx="71640" cy="69840"/>
          </a:xfrm>
          <a:prstGeom prst="rect">
            <a:avLst/>
          </a:prstGeom>
          <a:solidFill>
            <a:srgbClr val="3333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3966480" y="198360"/>
            <a:ext cx="21146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lv-LV" sz="1200" spc="-1" strike="noStrike">
                <a:solidFill>
                  <a:srgbClr val="000000"/>
                </a:solidFill>
                <a:latin typeface="Arial"/>
              </a:rPr>
              <a:t>SI to peptide aa 23-43/133-14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3832200" y="409680"/>
            <a:ext cx="71640" cy="6984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3966840" y="409680"/>
            <a:ext cx="2621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lv-LV" sz="1200" spc="-1" strike="noStrike">
                <a:solidFill>
                  <a:srgbClr val="000000"/>
                </a:solidFill>
                <a:latin typeface="Arial"/>
              </a:rPr>
              <a:t>SI to recombinant core aa 1-152/1-17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3513240" y="128520"/>
            <a:ext cx="3119400" cy="3451320"/>
          </a:xfrm>
          <a:prstGeom prst="rect">
            <a:avLst/>
          </a:pr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3472200" y="12852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3843360" y="1603440"/>
            <a:ext cx="2529000" cy="144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3843360" y="1446120"/>
            <a:ext cx="2529000" cy="180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3843360" y="1297080"/>
            <a:ext cx="2529000" cy="144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3843360" y="1147680"/>
            <a:ext cx="2529000" cy="180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3843360" y="998640"/>
            <a:ext cx="2529000" cy="144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3843360" y="841320"/>
            <a:ext cx="2529000" cy="180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3843360" y="692280"/>
            <a:ext cx="2529000" cy="144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4344840" y="1152360"/>
            <a:ext cx="122400" cy="597240"/>
          </a:xfrm>
          <a:prstGeom prst="rect">
            <a:avLst/>
          </a:prstGeom>
          <a:solidFill>
            <a:srgbClr val="333399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4768920" y="1343160"/>
            <a:ext cx="120600" cy="407880"/>
          </a:xfrm>
          <a:prstGeom prst="rect">
            <a:avLst/>
          </a:prstGeom>
          <a:solidFill>
            <a:srgbClr val="333399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4471920" y="1114560"/>
            <a:ext cx="119160" cy="637920"/>
          </a:xfrm>
          <a:prstGeom prst="rect">
            <a:avLst/>
          </a:prstGeom>
          <a:solidFill>
            <a:srgbClr val="ff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4889520" y="1325520"/>
            <a:ext cx="120600" cy="426960"/>
          </a:xfrm>
          <a:prstGeom prst="rect">
            <a:avLst/>
          </a:prstGeom>
          <a:solidFill>
            <a:srgbClr val="ff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8" name=""/>
          <p:cNvGrpSpPr/>
          <p:nvPr/>
        </p:nvGrpSpPr>
        <p:grpSpPr>
          <a:xfrm>
            <a:off x="4524480" y="1004760"/>
            <a:ext cx="23760" cy="210960"/>
            <a:chOff x="4524480" y="1004760"/>
            <a:chExt cx="23760" cy="210960"/>
          </a:xfrm>
        </p:grpSpPr>
        <p:sp>
          <p:nvSpPr>
            <p:cNvPr id="139" name=""/>
            <p:cNvSpPr/>
            <p:nvPr/>
          </p:nvSpPr>
          <p:spPr>
            <a:xfrm flipV="1">
              <a:off x="4534200" y="1004760"/>
              <a:ext cx="0" cy="104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4524480" y="1004760"/>
              <a:ext cx="23760" cy="2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4534200" y="1109160"/>
              <a:ext cx="0" cy="103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4524480" y="1213200"/>
              <a:ext cx="23760" cy="2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43" name=""/>
          <p:cNvGrpSpPr/>
          <p:nvPr/>
        </p:nvGrpSpPr>
        <p:grpSpPr>
          <a:xfrm>
            <a:off x="4390920" y="1044360"/>
            <a:ext cx="25560" cy="210960"/>
            <a:chOff x="4390920" y="1044360"/>
            <a:chExt cx="25560" cy="210960"/>
          </a:xfrm>
        </p:grpSpPr>
        <p:sp>
          <p:nvSpPr>
            <p:cNvPr id="144" name=""/>
            <p:cNvSpPr/>
            <p:nvPr/>
          </p:nvSpPr>
          <p:spPr>
            <a:xfrm flipV="1">
              <a:off x="4402800" y="1044360"/>
              <a:ext cx="0" cy="99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4390920" y="1044720"/>
              <a:ext cx="25560" cy="2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4402800" y="1143720"/>
              <a:ext cx="0" cy="109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4390920" y="1253520"/>
              <a:ext cx="255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8" name=""/>
          <p:cNvSpPr/>
          <p:nvPr/>
        </p:nvSpPr>
        <p:spPr>
          <a:xfrm>
            <a:off x="3843360" y="692280"/>
            <a:ext cx="0" cy="106020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3832200" y="1752480"/>
            <a:ext cx="11160" cy="180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3832200" y="1603440"/>
            <a:ext cx="11160" cy="144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3832200" y="1446120"/>
            <a:ext cx="11160" cy="180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3832200" y="1297080"/>
            <a:ext cx="11160" cy="144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3832200" y="1147680"/>
            <a:ext cx="11160" cy="180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3832200" y="998640"/>
            <a:ext cx="11160" cy="144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3832200" y="841320"/>
            <a:ext cx="11160" cy="180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3832200" y="692280"/>
            <a:ext cx="11160" cy="144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3843360" y="1752480"/>
            <a:ext cx="2529000" cy="180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 flipV="1">
            <a:off x="3843360" y="1752120"/>
            <a:ext cx="0" cy="2700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 flipV="1">
            <a:off x="4260960" y="1752120"/>
            <a:ext cx="1440" cy="2700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 flipV="1">
            <a:off x="4683240" y="1752120"/>
            <a:ext cx="0" cy="2700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5199120" y="1255680"/>
            <a:ext cx="119160" cy="496800"/>
          </a:xfrm>
          <a:prstGeom prst="rect">
            <a:avLst/>
          </a:prstGeom>
          <a:solidFill>
            <a:srgbClr val="333399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5616720" y="1397160"/>
            <a:ext cx="123840" cy="355320"/>
          </a:xfrm>
          <a:prstGeom prst="rect">
            <a:avLst/>
          </a:prstGeom>
          <a:solidFill>
            <a:srgbClr val="333399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6039000" y="1397160"/>
            <a:ext cx="118800" cy="355320"/>
          </a:xfrm>
          <a:prstGeom prst="rect">
            <a:avLst/>
          </a:prstGeom>
          <a:solidFill>
            <a:srgbClr val="333399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5318280" y="1114560"/>
            <a:ext cx="120600" cy="637920"/>
          </a:xfrm>
          <a:prstGeom prst="rect">
            <a:avLst/>
          </a:prstGeom>
          <a:solidFill>
            <a:srgbClr val="ff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5740560" y="1325520"/>
            <a:ext cx="118800" cy="426960"/>
          </a:xfrm>
          <a:prstGeom prst="rect">
            <a:avLst/>
          </a:prstGeom>
          <a:solidFill>
            <a:srgbClr val="ff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6157800" y="1325520"/>
            <a:ext cx="120600" cy="426960"/>
          </a:xfrm>
          <a:prstGeom prst="rect">
            <a:avLst/>
          </a:prstGeom>
          <a:solidFill>
            <a:srgbClr val="ff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7" name=""/>
          <p:cNvGrpSpPr/>
          <p:nvPr/>
        </p:nvGrpSpPr>
        <p:grpSpPr>
          <a:xfrm>
            <a:off x="4818240" y="1236600"/>
            <a:ext cx="25200" cy="212400"/>
            <a:chOff x="4818240" y="1236600"/>
            <a:chExt cx="25200" cy="212400"/>
          </a:xfrm>
        </p:grpSpPr>
        <p:sp>
          <p:nvSpPr>
            <p:cNvPr id="168" name=""/>
            <p:cNvSpPr/>
            <p:nvPr/>
          </p:nvSpPr>
          <p:spPr>
            <a:xfrm flipV="1">
              <a:off x="4828320" y="1236600"/>
              <a:ext cx="0" cy="105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4818240" y="1236600"/>
              <a:ext cx="25200" cy="2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4828320" y="1341720"/>
              <a:ext cx="0" cy="104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4818240" y="1446480"/>
              <a:ext cx="25200" cy="2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2" name=""/>
          <p:cNvGrpSpPr/>
          <p:nvPr/>
        </p:nvGrpSpPr>
        <p:grpSpPr>
          <a:xfrm>
            <a:off x="5665680" y="1250640"/>
            <a:ext cx="25560" cy="280800"/>
            <a:chOff x="5665680" y="1250640"/>
            <a:chExt cx="25560" cy="280800"/>
          </a:xfrm>
        </p:grpSpPr>
        <p:sp>
          <p:nvSpPr>
            <p:cNvPr id="173" name=""/>
            <p:cNvSpPr/>
            <p:nvPr/>
          </p:nvSpPr>
          <p:spPr>
            <a:xfrm flipV="1">
              <a:off x="5676120" y="1250640"/>
              <a:ext cx="1440" cy="14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5665680" y="1251000"/>
              <a:ext cx="25560" cy="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5676120" y="1391040"/>
              <a:ext cx="1440" cy="14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5665680" y="1531080"/>
              <a:ext cx="25560" cy="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7" name=""/>
          <p:cNvGrpSpPr/>
          <p:nvPr/>
        </p:nvGrpSpPr>
        <p:grpSpPr>
          <a:xfrm>
            <a:off x="6084720" y="1198440"/>
            <a:ext cx="25560" cy="404640"/>
            <a:chOff x="6084720" y="1198440"/>
            <a:chExt cx="25560" cy="404640"/>
          </a:xfrm>
        </p:grpSpPr>
        <p:sp>
          <p:nvSpPr>
            <p:cNvPr id="178" name=""/>
            <p:cNvSpPr/>
            <p:nvPr/>
          </p:nvSpPr>
          <p:spPr>
            <a:xfrm flipV="1">
              <a:off x="6095160" y="1198440"/>
              <a:ext cx="1080" cy="201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6084720" y="1198440"/>
              <a:ext cx="2556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6095160" y="1400040"/>
              <a:ext cx="1080" cy="201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6084720" y="1601640"/>
              <a:ext cx="255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2" name=""/>
          <p:cNvGrpSpPr/>
          <p:nvPr/>
        </p:nvGrpSpPr>
        <p:grpSpPr>
          <a:xfrm>
            <a:off x="4941720" y="1215720"/>
            <a:ext cx="25560" cy="210960"/>
            <a:chOff x="4941720" y="1215720"/>
            <a:chExt cx="25560" cy="210960"/>
          </a:xfrm>
        </p:grpSpPr>
        <p:sp>
          <p:nvSpPr>
            <p:cNvPr id="183" name=""/>
            <p:cNvSpPr/>
            <p:nvPr/>
          </p:nvSpPr>
          <p:spPr>
            <a:xfrm flipV="1">
              <a:off x="4953960" y="1215720"/>
              <a:ext cx="0" cy="99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4941720" y="1216080"/>
              <a:ext cx="25560" cy="2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4953960" y="1315080"/>
              <a:ext cx="0" cy="109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4941720" y="1424880"/>
              <a:ext cx="255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7" name=""/>
          <p:cNvGrpSpPr/>
          <p:nvPr/>
        </p:nvGrpSpPr>
        <p:grpSpPr>
          <a:xfrm>
            <a:off x="5788080" y="1184400"/>
            <a:ext cx="25200" cy="280440"/>
            <a:chOff x="5788080" y="1184400"/>
            <a:chExt cx="25200" cy="280440"/>
          </a:xfrm>
        </p:grpSpPr>
        <p:sp>
          <p:nvSpPr>
            <p:cNvPr id="188" name=""/>
            <p:cNvSpPr/>
            <p:nvPr/>
          </p:nvSpPr>
          <p:spPr>
            <a:xfrm flipV="1">
              <a:off x="5798160" y="1184400"/>
              <a:ext cx="0" cy="14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5788080" y="1184400"/>
              <a:ext cx="25200" cy="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5798160" y="1324800"/>
              <a:ext cx="0" cy="139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5788080" y="1464480"/>
              <a:ext cx="25200" cy="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2" name=""/>
          <p:cNvGrpSpPr/>
          <p:nvPr/>
        </p:nvGrpSpPr>
        <p:grpSpPr>
          <a:xfrm>
            <a:off x="6203880" y="1112400"/>
            <a:ext cx="27000" cy="406440"/>
            <a:chOff x="6203880" y="1112400"/>
            <a:chExt cx="27000" cy="406440"/>
          </a:xfrm>
        </p:grpSpPr>
        <p:sp>
          <p:nvSpPr>
            <p:cNvPr id="193" name=""/>
            <p:cNvSpPr/>
            <p:nvPr/>
          </p:nvSpPr>
          <p:spPr>
            <a:xfrm flipV="1">
              <a:off x="6215760" y="1112400"/>
              <a:ext cx="0" cy="202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6203880" y="1112760"/>
              <a:ext cx="270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6215760" y="1315440"/>
              <a:ext cx="0" cy="202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6203880" y="1517760"/>
              <a:ext cx="2700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97" name=""/>
          <p:cNvSpPr/>
          <p:nvPr/>
        </p:nvSpPr>
        <p:spPr>
          <a:xfrm>
            <a:off x="5100480" y="1752480"/>
            <a:ext cx="11160" cy="180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 flipV="1">
            <a:off x="5111640" y="1752120"/>
            <a:ext cx="0" cy="2700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 flipV="1">
            <a:off x="5529240" y="1752120"/>
            <a:ext cx="1440" cy="2700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 flipV="1">
            <a:off x="5951520" y="1752120"/>
            <a:ext cx="0" cy="2700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01" name=""/>
          <p:cNvGrpSpPr/>
          <p:nvPr/>
        </p:nvGrpSpPr>
        <p:grpSpPr>
          <a:xfrm>
            <a:off x="5245200" y="1071360"/>
            <a:ext cx="25200" cy="352440"/>
            <a:chOff x="5245200" y="1071360"/>
            <a:chExt cx="25200" cy="352440"/>
          </a:xfrm>
        </p:grpSpPr>
        <p:sp>
          <p:nvSpPr>
            <p:cNvPr id="202" name=""/>
            <p:cNvSpPr/>
            <p:nvPr/>
          </p:nvSpPr>
          <p:spPr>
            <a:xfrm flipV="1">
              <a:off x="5255280" y="1071360"/>
              <a:ext cx="1440" cy="175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5245200" y="1071720"/>
              <a:ext cx="2520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5255280" y="1247040"/>
              <a:ext cx="1440" cy="175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5245200" y="1422360"/>
              <a:ext cx="252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06" name=""/>
          <p:cNvGrpSpPr/>
          <p:nvPr/>
        </p:nvGrpSpPr>
        <p:grpSpPr>
          <a:xfrm>
            <a:off x="5369040" y="902880"/>
            <a:ext cx="25200" cy="405000"/>
            <a:chOff x="5369040" y="902880"/>
            <a:chExt cx="25200" cy="405000"/>
          </a:xfrm>
        </p:grpSpPr>
        <p:sp>
          <p:nvSpPr>
            <p:cNvPr id="207" name=""/>
            <p:cNvSpPr/>
            <p:nvPr/>
          </p:nvSpPr>
          <p:spPr>
            <a:xfrm flipV="1">
              <a:off x="5380200" y="902880"/>
              <a:ext cx="0" cy="201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5369040" y="903240"/>
              <a:ext cx="252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5380200" y="1105200"/>
              <a:ext cx="0" cy="201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5369040" y="1306800"/>
              <a:ext cx="2520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11" name=""/>
          <p:cNvSpPr/>
          <p:nvPr/>
        </p:nvSpPr>
        <p:spPr>
          <a:xfrm rot="16200000">
            <a:off x="4686120" y="2179440"/>
            <a:ext cx="12214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lv-LV" sz="1200" spc="-1" strike="noStrike">
                <a:solidFill>
                  <a:srgbClr val="000000"/>
                </a:solidFill>
                <a:latin typeface="Arial"/>
              </a:rPr>
              <a:t>pCMVKoza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lv-LV" sz="1200" spc="-1" strike="noStrike">
                <a:solidFill>
                  <a:srgbClr val="000000"/>
                </a:solidFill>
                <a:latin typeface="Arial"/>
              </a:rPr>
              <a:t>C57BL6 (n=10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 rot="16200000">
            <a:off x="4897440" y="2320920"/>
            <a:ext cx="16682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lv-LV" sz="1200" spc="-1" strike="noStrike">
                <a:solidFill>
                  <a:srgbClr val="000000"/>
                </a:solidFill>
                <a:latin typeface="Arial"/>
              </a:rPr>
              <a:t>Empty vector BALB/c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lv-LV" sz="1200" spc="-1" strike="noStrike">
                <a:solidFill>
                  <a:srgbClr val="000000"/>
                </a:solidFill>
                <a:latin typeface="Arial"/>
              </a:rPr>
              <a:t>(n=4), C57BL6 (n=12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 rot="16200000">
            <a:off x="5393520" y="2334960"/>
            <a:ext cx="16894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lacebo BALB/c(n=4),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57BL6 (n=12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4346640" y="3297240"/>
            <a:ext cx="122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ouse group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3760920" y="1255680"/>
            <a:ext cx="569880" cy="55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lv-LV" sz="1200" spc="-1" strike="noStrike">
                <a:solidFill>
                  <a:srgbClr val="000000"/>
                </a:solidFill>
                <a:latin typeface="Arial"/>
              </a:rPr>
              <a:t>No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lv-LV" sz="1200" spc="-1" strike="noStrike">
                <a:solidFill>
                  <a:srgbClr val="000000"/>
                </a:solidFill>
                <a:latin typeface="Arial"/>
              </a:rPr>
              <a:t>do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 flipH="1">
            <a:off x="835200" y="4352760"/>
            <a:ext cx="5680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691200" y="47736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547200" y="428292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547200" y="371952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 rot="16200000">
            <a:off x="1295280" y="5287680"/>
            <a:ext cx="114660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CMVcoreKoza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ALB/c (n=4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 rot="16200000">
            <a:off x="815760" y="5181120"/>
            <a:ext cx="124884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lv-LV" sz="1200" spc="-1" strike="noStrike">
                <a:solidFill>
                  <a:srgbClr val="000000"/>
                </a:solidFill>
                <a:latin typeface="Arial"/>
              </a:rPr>
              <a:t>pCMVcoreIRES</a:t>
            </a:r>
            <a:r>
              <a:rPr b="0" lang="sv-SE" sz="1200" spc="-1" strike="noStrike">
                <a:solidFill>
                  <a:srgbClr val="000000"/>
                </a:solidFill>
                <a:latin typeface="Arial"/>
              </a:rPr>
              <a:t>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lv-LV" sz="1200" spc="-1" strike="noStrike">
                <a:solidFill>
                  <a:srgbClr val="000000"/>
                </a:solidFill>
                <a:latin typeface="Arial"/>
              </a:rPr>
              <a:t>BALB/c (n=4)</a:t>
            </a:r>
            <a:r>
              <a:rPr b="0" lang="sv-SE" sz="12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 rot="16200000">
            <a:off x="551160" y="5173560"/>
            <a:ext cx="91368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CMVcor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ALB/c (n=4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1189080" y="6251400"/>
            <a:ext cx="104328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lv-LV" sz="1200" spc="-1" strike="noStrike">
                <a:solidFill>
                  <a:srgbClr val="000000"/>
                </a:solidFill>
                <a:latin typeface="Arial"/>
              </a:rPr>
              <a:t>Mouse group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 rot="16200000">
            <a:off x="-138960" y="4098960"/>
            <a:ext cx="11376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lv-LV" sz="1200" spc="-1" strike="noStrike">
                <a:solidFill>
                  <a:srgbClr val="000000"/>
                </a:solidFill>
                <a:latin typeface="Arial"/>
              </a:rPr>
              <a:t>Cytokine, pg/m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905040" y="3298680"/>
            <a:ext cx="71280" cy="69840"/>
          </a:xfrm>
          <a:prstGeom prst="rect">
            <a:avLst/>
          </a:prstGeom>
          <a:solidFill>
            <a:srgbClr val="333399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1119240" y="3298680"/>
            <a:ext cx="3726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lv-LV" sz="1200" spc="-1" strike="noStrike">
                <a:solidFill>
                  <a:srgbClr val="000000"/>
                </a:solidFill>
                <a:latin typeface="Arial"/>
              </a:rPr>
              <a:t>IFN-</a:t>
            </a:r>
            <a:r>
              <a:rPr b="0" lang="el-GR" sz="1200" spc="-1" strike="noStrike">
                <a:solidFill>
                  <a:srgbClr val="000000"/>
                </a:solidFill>
                <a:latin typeface="Arial"/>
                <a:ea typeface="Arial"/>
              </a:rPr>
              <a:t>γ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1617840" y="3298680"/>
            <a:ext cx="69840" cy="69840"/>
          </a:xfrm>
          <a:prstGeom prst="rect">
            <a:avLst/>
          </a:prstGeom>
          <a:solidFill>
            <a:srgbClr val="ff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1759320" y="3298680"/>
            <a:ext cx="264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L-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2187720" y="3298680"/>
            <a:ext cx="69840" cy="69840"/>
          </a:xfrm>
          <a:prstGeom prst="rect">
            <a:avLst/>
          </a:prstGeom>
          <a:solidFill>
            <a:srgbClr val="ffff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2329200" y="3298680"/>
            <a:ext cx="264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L-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334800" y="3227400"/>
            <a:ext cx="3063960" cy="3233880"/>
          </a:xfrm>
          <a:prstGeom prst="rect">
            <a:avLst/>
          </a:pr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847800" y="4597560"/>
            <a:ext cx="2411280" cy="144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847800" y="4343400"/>
            <a:ext cx="2411280" cy="144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847800" y="4091040"/>
            <a:ext cx="2411280" cy="144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847800" y="3838680"/>
            <a:ext cx="2411280" cy="144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846000" y="3584520"/>
            <a:ext cx="2411640" cy="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1306440" y="3654360"/>
            <a:ext cx="87480" cy="1195560"/>
          </a:xfrm>
          <a:prstGeom prst="rect">
            <a:avLst/>
          </a:prstGeom>
          <a:solidFill>
            <a:srgbClr val="333399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1700280" y="3865680"/>
            <a:ext cx="88920" cy="984240"/>
          </a:xfrm>
          <a:prstGeom prst="rect">
            <a:avLst/>
          </a:prstGeom>
          <a:solidFill>
            <a:srgbClr val="333399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3062160" y="4818240"/>
            <a:ext cx="85680" cy="28440"/>
          </a:xfrm>
          <a:prstGeom prst="rect">
            <a:avLst/>
          </a:prstGeom>
          <a:solidFill>
            <a:srgbClr val="ffff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1393920" y="4305240"/>
            <a:ext cx="87120" cy="542880"/>
          </a:xfrm>
          <a:prstGeom prst="rect">
            <a:avLst/>
          </a:prstGeom>
          <a:solidFill>
            <a:srgbClr val="ff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1789200" y="4038480"/>
            <a:ext cx="83880" cy="808200"/>
          </a:xfrm>
          <a:prstGeom prst="rect">
            <a:avLst/>
          </a:prstGeom>
          <a:solidFill>
            <a:srgbClr val="ff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2281320" y="4835520"/>
            <a:ext cx="87120" cy="11160"/>
          </a:xfrm>
          <a:prstGeom prst="rect">
            <a:avLst/>
          </a:prstGeom>
          <a:solidFill>
            <a:srgbClr val="ffff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847800" y="3584520"/>
            <a:ext cx="0" cy="126540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836640" y="4849920"/>
            <a:ext cx="11160" cy="144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836640" y="4597560"/>
            <a:ext cx="11160" cy="144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836640" y="4343400"/>
            <a:ext cx="11160" cy="144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836640" y="4091040"/>
            <a:ext cx="11160" cy="144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836640" y="3838680"/>
            <a:ext cx="11160" cy="144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836640" y="3584520"/>
            <a:ext cx="11160" cy="180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 flipV="1">
            <a:off x="836640" y="4847760"/>
            <a:ext cx="2411280" cy="180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 flipV="1">
            <a:off x="847800" y="4849560"/>
            <a:ext cx="0" cy="2988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920" bIns="-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 flipV="1">
            <a:off x="1241280" y="4849560"/>
            <a:ext cx="0" cy="2988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920" bIns="-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 flipV="1">
            <a:off x="1635120" y="4849560"/>
            <a:ext cx="0" cy="2988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920" bIns="-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 flipV="1">
            <a:off x="2027160" y="4849560"/>
            <a:ext cx="0" cy="2988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920" bIns="-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2100240" y="4427640"/>
            <a:ext cx="88920" cy="422280"/>
          </a:xfrm>
          <a:prstGeom prst="rect">
            <a:avLst/>
          </a:prstGeom>
          <a:solidFill>
            <a:srgbClr val="333399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2494080" y="4792680"/>
            <a:ext cx="87120" cy="54000"/>
          </a:xfrm>
          <a:prstGeom prst="rect">
            <a:avLst/>
          </a:prstGeom>
          <a:solidFill>
            <a:srgbClr val="333399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2887560" y="4826160"/>
            <a:ext cx="88920" cy="21960"/>
          </a:xfrm>
          <a:prstGeom prst="rect">
            <a:avLst/>
          </a:prstGeom>
          <a:solidFill>
            <a:srgbClr val="333399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2189160" y="4498920"/>
            <a:ext cx="85680" cy="351000"/>
          </a:xfrm>
          <a:prstGeom prst="rect">
            <a:avLst/>
          </a:prstGeom>
          <a:solidFill>
            <a:srgbClr val="ff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>
            <a:off x="2581200" y="4835520"/>
            <a:ext cx="87480" cy="15840"/>
          </a:xfrm>
          <a:prstGeom prst="rect">
            <a:avLst/>
          </a:prstGeom>
          <a:solidFill>
            <a:srgbClr val="ff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2976480" y="4780080"/>
            <a:ext cx="84240" cy="69840"/>
          </a:xfrm>
          <a:prstGeom prst="rect">
            <a:avLst/>
          </a:prstGeom>
          <a:solidFill>
            <a:srgbClr val="ff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 flipV="1" rot="10800000">
            <a:off x="2668320" y="4764600"/>
            <a:ext cx="88920" cy="81000"/>
          </a:xfrm>
          <a:prstGeom prst="rect">
            <a:avLst/>
          </a:prstGeom>
          <a:solidFill>
            <a:srgbClr val="ffff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>
            <a:off x="2023920" y="4849920"/>
            <a:ext cx="11160" cy="144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 flipV="1">
            <a:off x="2428920" y="4849560"/>
            <a:ext cx="0" cy="2988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920" bIns="-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 flipV="1">
            <a:off x="2822400" y="4849560"/>
            <a:ext cx="0" cy="2988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920" bIns="-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65" name=""/>
          <p:cNvGrpSpPr/>
          <p:nvPr/>
        </p:nvGrpSpPr>
        <p:grpSpPr>
          <a:xfrm>
            <a:off x="2217600" y="4189320"/>
            <a:ext cx="29880" cy="590400"/>
            <a:chOff x="2217600" y="4189320"/>
            <a:chExt cx="29880" cy="590400"/>
          </a:xfrm>
        </p:grpSpPr>
        <p:sp>
          <p:nvSpPr>
            <p:cNvPr id="266" name=""/>
            <p:cNvSpPr/>
            <p:nvPr/>
          </p:nvSpPr>
          <p:spPr>
            <a:xfrm>
              <a:off x="2233440" y="4189320"/>
              <a:ext cx="1440" cy="58932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2217600" y="4189320"/>
              <a:ext cx="29880" cy="1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2217600" y="4778640"/>
              <a:ext cx="29880" cy="108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69" name=""/>
          <p:cNvSpPr/>
          <p:nvPr/>
        </p:nvSpPr>
        <p:spPr>
          <a:xfrm>
            <a:off x="3255840" y="3584520"/>
            <a:ext cx="0" cy="127008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70" name=""/>
          <p:cNvGrpSpPr/>
          <p:nvPr/>
        </p:nvGrpSpPr>
        <p:grpSpPr>
          <a:xfrm>
            <a:off x="2309760" y="4815000"/>
            <a:ext cx="31320" cy="34920"/>
            <a:chOff x="2309760" y="4815000"/>
            <a:chExt cx="31320" cy="34920"/>
          </a:xfrm>
        </p:grpSpPr>
        <p:sp>
          <p:nvSpPr>
            <p:cNvPr id="271" name=""/>
            <p:cNvSpPr/>
            <p:nvPr/>
          </p:nvSpPr>
          <p:spPr>
            <a:xfrm>
              <a:off x="2326320" y="4815000"/>
              <a:ext cx="1800" cy="34920"/>
            </a:xfrm>
            <a:prstGeom prst="line">
              <a:avLst/>
            </a:prstGeom>
            <a:ln cap="rnd"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2309760" y="4815000"/>
              <a:ext cx="31320" cy="0"/>
            </a:xfrm>
            <a:prstGeom prst="line">
              <a:avLst/>
            </a:prstGeom>
            <a:ln cap="rnd"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>
              <a:off x="2309760" y="4849920"/>
              <a:ext cx="31320" cy="0"/>
            </a:xfrm>
            <a:prstGeom prst="line">
              <a:avLst/>
            </a:prstGeom>
            <a:ln cap="rnd"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74" name=""/>
          <p:cNvGrpSpPr/>
          <p:nvPr/>
        </p:nvGrpSpPr>
        <p:grpSpPr>
          <a:xfrm>
            <a:off x="2517840" y="4754520"/>
            <a:ext cx="31320" cy="88920"/>
            <a:chOff x="2517840" y="4754520"/>
            <a:chExt cx="31320" cy="88920"/>
          </a:xfrm>
        </p:grpSpPr>
        <p:sp>
          <p:nvSpPr>
            <p:cNvPr id="275" name=""/>
            <p:cNvSpPr/>
            <p:nvPr/>
          </p:nvSpPr>
          <p:spPr>
            <a:xfrm>
              <a:off x="2534400" y="4754520"/>
              <a:ext cx="1800" cy="88920"/>
            </a:xfrm>
            <a:prstGeom prst="line">
              <a:avLst/>
            </a:prstGeom>
            <a:ln cap="rnd"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120" bIns="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2517840" y="4754520"/>
              <a:ext cx="31320" cy="0"/>
            </a:xfrm>
            <a:prstGeom prst="line">
              <a:avLst/>
            </a:prstGeom>
            <a:ln cap="rnd"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2517840" y="4843440"/>
              <a:ext cx="31320" cy="0"/>
            </a:xfrm>
            <a:prstGeom prst="line">
              <a:avLst/>
            </a:prstGeom>
            <a:ln cap="rnd"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78" name=""/>
          <p:cNvGrpSpPr/>
          <p:nvPr/>
        </p:nvGrpSpPr>
        <p:grpSpPr>
          <a:xfrm>
            <a:off x="2697120" y="4719600"/>
            <a:ext cx="30240" cy="128160"/>
            <a:chOff x="2697120" y="4719600"/>
            <a:chExt cx="30240" cy="128160"/>
          </a:xfrm>
        </p:grpSpPr>
        <p:sp>
          <p:nvSpPr>
            <p:cNvPr id="279" name=""/>
            <p:cNvSpPr/>
            <p:nvPr/>
          </p:nvSpPr>
          <p:spPr>
            <a:xfrm>
              <a:off x="2712960" y="4719600"/>
              <a:ext cx="1800" cy="1281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2697120" y="4719600"/>
              <a:ext cx="30240" cy="3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>
              <a:off x="2697120" y="4847760"/>
              <a:ext cx="302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82" name=""/>
          <p:cNvGrpSpPr/>
          <p:nvPr/>
        </p:nvGrpSpPr>
        <p:grpSpPr>
          <a:xfrm>
            <a:off x="2125800" y="4357800"/>
            <a:ext cx="31320" cy="140760"/>
            <a:chOff x="2125800" y="4357800"/>
            <a:chExt cx="31320" cy="140760"/>
          </a:xfrm>
        </p:grpSpPr>
        <p:sp>
          <p:nvSpPr>
            <p:cNvPr id="283" name=""/>
            <p:cNvSpPr/>
            <p:nvPr/>
          </p:nvSpPr>
          <p:spPr>
            <a:xfrm>
              <a:off x="2142360" y="4357800"/>
              <a:ext cx="1800" cy="1407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>
              <a:off x="2125800" y="4357800"/>
              <a:ext cx="31320" cy="3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>
              <a:off x="2125800" y="4498560"/>
              <a:ext cx="3132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86" name=""/>
          <p:cNvGrpSpPr/>
          <p:nvPr/>
        </p:nvGrpSpPr>
        <p:grpSpPr>
          <a:xfrm>
            <a:off x="2606760" y="4807080"/>
            <a:ext cx="30240" cy="41040"/>
            <a:chOff x="2606760" y="4807080"/>
            <a:chExt cx="30240" cy="41040"/>
          </a:xfrm>
        </p:grpSpPr>
        <p:sp>
          <p:nvSpPr>
            <p:cNvPr id="287" name=""/>
            <p:cNvSpPr/>
            <p:nvPr/>
          </p:nvSpPr>
          <p:spPr>
            <a:xfrm>
              <a:off x="2622600" y="4807080"/>
              <a:ext cx="1800" cy="410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>
              <a:off x="2606760" y="4807080"/>
              <a:ext cx="302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2606760" y="4848120"/>
              <a:ext cx="302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90" name=""/>
          <p:cNvGrpSpPr/>
          <p:nvPr/>
        </p:nvGrpSpPr>
        <p:grpSpPr>
          <a:xfrm>
            <a:off x="2919240" y="4765680"/>
            <a:ext cx="30240" cy="81000"/>
            <a:chOff x="2919240" y="4765680"/>
            <a:chExt cx="30240" cy="81000"/>
          </a:xfrm>
        </p:grpSpPr>
        <p:sp>
          <p:nvSpPr>
            <p:cNvPr id="291" name=""/>
            <p:cNvSpPr/>
            <p:nvPr/>
          </p:nvSpPr>
          <p:spPr>
            <a:xfrm>
              <a:off x="2935080" y="4765680"/>
              <a:ext cx="1800" cy="810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2919240" y="4765680"/>
              <a:ext cx="302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>
              <a:off x="2919240" y="4846680"/>
              <a:ext cx="302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94" name=""/>
          <p:cNvGrpSpPr/>
          <p:nvPr/>
        </p:nvGrpSpPr>
        <p:grpSpPr>
          <a:xfrm>
            <a:off x="3000240" y="4754520"/>
            <a:ext cx="31680" cy="41400"/>
            <a:chOff x="3000240" y="4754520"/>
            <a:chExt cx="31680" cy="41400"/>
          </a:xfrm>
        </p:grpSpPr>
        <p:sp>
          <p:nvSpPr>
            <p:cNvPr id="295" name=""/>
            <p:cNvSpPr/>
            <p:nvPr/>
          </p:nvSpPr>
          <p:spPr>
            <a:xfrm>
              <a:off x="3016800" y="4754520"/>
              <a:ext cx="1800" cy="414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"/>
            <p:cNvSpPr/>
            <p:nvPr/>
          </p:nvSpPr>
          <p:spPr>
            <a:xfrm>
              <a:off x="3000240" y="4754520"/>
              <a:ext cx="3168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"/>
            <p:cNvSpPr/>
            <p:nvPr/>
          </p:nvSpPr>
          <p:spPr>
            <a:xfrm>
              <a:off x="3000240" y="4795920"/>
              <a:ext cx="3168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98" name=""/>
          <p:cNvGrpSpPr/>
          <p:nvPr/>
        </p:nvGrpSpPr>
        <p:grpSpPr>
          <a:xfrm>
            <a:off x="3089160" y="4719600"/>
            <a:ext cx="30240" cy="128160"/>
            <a:chOff x="3089160" y="4719600"/>
            <a:chExt cx="30240" cy="128160"/>
          </a:xfrm>
        </p:grpSpPr>
        <p:sp>
          <p:nvSpPr>
            <p:cNvPr id="299" name=""/>
            <p:cNvSpPr/>
            <p:nvPr/>
          </p:nvSpPr>
          <p:spPr>
            <a:xfrm>
              <a:off x="3105000" y="4719600"/>
              <a:ext cx="1800" cy="1281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"/>
            <p:cNvSpPr/>
            <p:nvPr/>
          </p:nvSpPr>
          <p:spPr>
            <a:xfrm>
              <a:off x="3089160" y="4719600"/>
              <a:ext cx="30240" cy="3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"/>
            <p:cNvSpPr/>
            <p:nvPr/>
          </p:nvSpPr>
          <p:spPr>
            <a:xfrm>
              <a:off x="3089160" y="4847760"/>
              <a:ext cx="302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02" name=""/>
          <p:cNvSpPr/>
          <p:nvPr/>
        </p:nvSpPr>
        <p:spPr>
          <a:xfrm>
            <a:off x="336600" y="322740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lv-LV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"/>
          <p:cNvSpPr/>
          <p:nvPr/>
        </p:nvSpPr>
        <p:spPr>
          <a:xfrm>
            <a:off x="762120" y="4282920"/>
            <a:ext cx="555480" cy="55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lv-LV" sz="1200" spc="-1" strike="noStrike">
                <a:solidFill>
                  <a:srgbClr val="000000"/>
                </a:solidFill>
                <a:latin typeface="Arial"/>
              </a:rPr>
              <a:t>No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lv-LV" sz="1200" spc="-1" strike="noStrike">
                <a:solidFill>
                  <a:srgbClr val="000000"/>
                </a:solidFill>
                <a:latin typeface="Arial"/>
              </a:rPr>
              <a:t>do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"/>
          <p:cNvSpPr/>
          <p:nvPr/>
        </p:nvSpPr>
        <p:spPr>
          <a:xfrm rot="16200000">
            <a:off x="1623960" y="5162400"/>
            <a:ext cx="13096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lv-LV" sz="1200" spc="-1" strike="noStrike">
                <a:solidFill>
                  <a:srgbClr val="000000"/>
                </a:solidFill>
                <a:latin typeface="Arial"/>
              </a:rPr>
              <a:t>pCMVKoza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lv-LV" sz="1200" spc="-1" strike="noStrike">
                <a:solidFill>
                  <a:srgbClr val="000000"/>
                </a:solidFill>
                <a:latin typeface="Arial"/>
              </a:rPr>
              <a:t>C57BL6 (n=10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"/>
          <p:cNvSpPr/>
          <p:nvPr/>
        </p:nvSpPr>
        <p:spPr>
          <a:xfrm rot="16200000">
            <a:off x="1877400" y="5352120"/>
            <a:ext cx="17287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lv-LV" sz="1200" spc="-1" strike="noStrike">
                <a:solidFill>
                  <a:srgbClr val="000000"/>
                </a:solidFill>
                <a:latin typeface="Arial"/>
              </a:rPr>
              <a:t>Empty vector BALB/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lv-LV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lv-LV" sz="1200" spc="-1" strike="noStrike">
                <a:solidFill>
                  <a:srgbClr val="000000"/>
                </a:solidFill>
                <a:latin typeface="Arial"/>
              </a:rPr>
              <a:t>(n=4), C57BL6 (n=12)</a:t>
            </a:r>
            <a:r>
              <a:rPr b="0" lang="sv-SE" sz="12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"/>
          <p:cNvSpPr/>
          <p:nvPr/>
        </p:nvSpPr>
        <p:spPr>
          <a:xfrm rot="16200000">
            <a:off x="2152800" y="5385240"/>
            <a:ext cx="18176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lv-LV" sz="1200" spc="-1" strike="noStrike">
                <a:solidFill>
                  <a:srgbClr val="000000"/>
                </a:solidFill>
                <a:latin typeface="Arial"/>
              </a:rPr>
              <a:t>Placebo BALB/c (n=4),</a:t>
            </a:r>
            <a:r>
              <a:rPr b="0" lang="sv-SE" sz="12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lv-LV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lv-LV" sz="1200" spc="-1" strike="noStrike">
                <a:solidFill>
                  <a:srgbClr val="000000"/>
                </a:solidFill>
                <a:latin typeface="Arial"/>
              </a:rPr>
              <a:t>C57BL6 (n=12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>
            <a:off x="6369120" y="693720"/>
            <a:ext cx="0" cy="106056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7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1-13T13:31:25Z</dcterms:created>
  <dc:creator>LBMC</dc:creator>
  <dc:description/>
  <dc:language>en-US</dc:language>
  <cp:lastModifiedBy>LBMC</cp:lastModifiedBy>
  <dcterms:modified xsi:type="dcterms:W3CDTF">2009-05-20T06:49:02Z</dcterms:modified>
  <cp:revision>19</cp:revision>
  <dc:subject/>
  <dc:title>Slide 1</dc:title>
</cp:coreProperties>
</file>